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100" d="100"/>
          <a:sy n="100" d="100"/>
        </p:scale>
        <p:origin x="-72" y="134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s-ES_tradnl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_tradnl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8CA3A-1B56-2242-8E8E-10177C94E442}" type="datetimeFigureOut">
              <a:rPr lang="en-US" smtClean="0"/>
              <a:pPr/>
              <a:t>8/2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0EAD3C-6716-144E-8A51-58CFD79B9187}" type="slidenum">
              <a:rPr lang="en-US" smtClean="0"/>
              <a:pPr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2595814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_tradnl" smtClean="0"/>
              <a:t>Click to edit Master text styles</a:t>
            </a:r>
          </a:p>
          <a:p>
            <a:pPr lvl="1"/>
            <a:r>
              <a:rPr lang="es-ES_tradnl" smtClean="0"/>
              <a:t>Second level</a:t>
            </a:r>
          </a:p>
          <a:p>
            <a:pPr lvl="2"/>
            <a:r>
              <a:rPr lang="es-ES_tradnl" smtClean="0"/>
              <a:t>Third level</a:t>
            </a:r>
          </a:p>
          <a:p>
            <a:pPr lvl="3"/>
            <a:r>
              <a:rPr lang="es-ES_tradnl" smtClean="0"/>
              <a:t>Fourth level</a:t>
            </a:r>
          </a:p>
          <a:p>
            <a:pPr lvl="4"/>
            <a:r>
              <a:rPr lang="es-ES_tradnl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8CA3A-1B56-2242-8E8E-10177C94E442}" type="datetimeFigureOut">
              <a:rPr lang="en-US" smtClean="0"/>
              <a:pPr/>
              <a:t>8/2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0EAD3C-6716-144E-8A51-58CFD79B9187}" type="slidenum">
              <a:rPr lang="en-US" smtClean="0"/>
              <a:pPr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42008691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s-ES_tradnl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s-ES_tradnl" smtClean="0"/>
              <a:t>Click to edit Master text styles</a:t>
            </a:r>
          </a:p>
          <a:p>
            <a:pPr lvl="1"/>
            <a:r>
              <a:rPr lang="es-ES_tradnl" smtClean="0"/>
              <a:t>Second level</a:t>
            </a:r>
          </a:p>
          <a:p>
            <a:pPr lvl="2"/>
            <a:r>
              <a:rPr lang="es-ES_tradnl" smtClean="0"/>
              <a:t>Third level</a:t>
            </a:r>
          </a:p>
          <a:p>
            <a:pPr lvl="3"/>
            <a:r>
              <a:rPr lang="es-ES_tradnl" smtClean="0"/>
              <a:t>Fourth level</a:t>
            </a:r>
          </a:p>
          <a:p>
            <a:pPr lvl="4"/>
            <a:r>
              <a:rPr lang="es-ES_tradnl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8CA3A-1B56-2242-8E8E-10177C94E442}" type="datetimeFigureOut">
              <a:rPr lang="en-US" smtClean="0"/>
              <a:pPr/>
              <a:t>8/2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0EAD3C-6716-144E-8A51-58CFD79B9187}" type="slidenum">
              <a:rPr lang="en-US" smtClean="0"/>
              <a:pPr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6966514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_tradnl" smtClean="0"/>
              <a:t>Click to edit Master text styles</a:t>
            </a:r>
          </a:p>
          <a:p>
            <a:pPr lvl="1"/>
            <a:r>
              <a:rPr lang="es-ES_tradnl" smtClean="0"/>
              <a:t>Second level</a:t>
            </a:r>
          </a:p>
          <a:p>
            <a:pPr lvl="2"/>
            <a:r>
              <a:rPr lang="es-ES_tradnl" smtClean="0"/>
              <a:t>Third level</a:t>
            </a:r>
          </a:p>
          <a:p>
            <a:pPr lvl="3"/>
            <a:r>
              <a:rPr lang="es-ES_tradnl" smtClean="0"/>
              <a:t>Fourth level</a:t>
            </a:r>
          </a:p>
          <a:p>
            <a:pPr lvl="4"/>
            <a:r>
              <a:rPr lang="es-ES_tradnl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8CA3A-1B56-2242-8E8E-10177C94E442}" type="datetimeFigureOut">
              <a:rPr lang="en-US" smtClean="0"/>
              <a:pPr/>
              <a:t>8/2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0EAD3C-6716-144E-8A51-58CFD79B9187}" type="slidenum">
              <a:rPr lang="en-US" smtClean="0"/>
              <a:pPr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3846845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_tradnl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_tradnl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8CA3A-1B56-2242-8E8E-10177C94E442}" type="datetimeFigureOut">
              <a:rPr lang="en-US" smtClean="0"/>
              <a:pPr/>
              <a:t>8/2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0EAD3C-6716-144E-8A51-58CFD79B9187}" type="slidenum">
              <a:rPr lang="en-US" smtClean="0"/>
              <a:pPr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1392351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 smtClean="0"/>
              <a:t>Click to edit Master text styles</a:t>
            </a:r>
          </a:p>
          <a:p>
            <a:pPr lvl="1"/>
            <a:r>
              <a:rPr lang="es-ES_tradnl" smtClean="0"/>
              <a:t>Second level</a:t>
            </a:r>
          </a:p>
          <a:p>
            <a:pPr lvl="2"/>
            <a:r>
              <a:rPr lang="es-ES_tradnl" smtClean="0"/>
              <a:t>Third level</a:t>
            </a:r>
          </a:p>
          <a:p>
            <a:pPr lvl="3"/>
            <a:r>
              <a:rPr lang="es-ES_tradnl" smtClean="0"/>
              <a:t>Fourth level</a:t>
            </a:r>
          </a:p>
          <a:p>
            <a:pPr lvl="4"/>
            <a:r>
              <a:rPr lang="es-ES_tradnl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 smtClean="0"/>
              <a:t>Click to edit Master text styles</a:t>
            </a:r>
          </a:p>
          <a:p>
            <a:pPr lvl="1"/>
            <a:r>
              <a:rPr lang="es-ES_tradnl" smtClean="0"/>
              <a:t>Second level</a:t>
            </a:r>
          </a:p>
          <a:p>
            <a:pPr lvl="2"/>
            <a:r>
              <a:rPr lang="es-ES_tradnl" smtClean="0"/>
              <a:t>Third level</a:t>
            </a:r>
          </a:p>
          <a:p>
            <a:pPr lvl="3"/>
            <a:r>
              <a:rPr lang="es-ES_tradnl" smtClean="0"/>
              <a:t>Fourth level</a:t>
            </a:r>
          </a:p>
          <a:p>
            <a:pPr lvl="4"/>
            <a:r>
              <a:rPr lang="es-ES_tradnl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8CA3A-1B56-2242-8E8E-10177C94E442}" type="datetimeFigureOut">
              <a:rPr lang="en-US" smtClean="0"/>
              <a:pPr/>
              <a:t>8/20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0EAD3C-6716-144E-8A51-58CFD79B9187}" type="slidenum">
              <a:rPr lang="en-US" smtClean="0"/>
              <a:pPr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5129343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_tradnl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 smtClean="0"/>
              <a:t>Click to edit Master text styles</a:t>
            </a:r>
          </a:p>
          <a:p>
            <a:pPr lvl="1"/>
            <a:r>
              <a:rPr lang="es-ES_tradnl" smtClean="0"/>
              <a:t>Second level</a:t>
            </a:r>
          </a:p>
          <a:p>
            <a:pPr lvl="2"/>
            <a:r>
              <a:rPr lang="es-ES_tradnl" smtClean="0"/>
              <a:t>Third level</a:t>
            </a:r>
          </a:p>
          <a:p>
            <a:pPr lvl="3"/>
            <a:r>
              <a:rPr lang="es-ES_tradnl" smtClean="0"/>
              <a:t>Fourth level</a:t>
            </a:r>
          </a:p>
          <a:p>
            <a:pPr lvl="4"/>
            <a:r>
              <a:rPr lang="es-ES_tradnl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 smtClean="0"/>
              <a:t>Click to edit Master text styles</a:t>
            </a:r>
          </a:p>
          <a:p>
            <a:pPr lvl="1"/>
            <a:r>
              <a:rPr lang="es-ES_tradnl" smtClean="0"/>
              <a:t>Second level</a:t>
            </a:r>
          </a:p>
          <a:p>
            <a:pPr lvl="2"/>
            <a:r>
              <a:rPr lang="es-ES_tradnl" smtClean="0"/>
              <a:t>Third level</a:t>
            </a:r>
          </a:p>
          <a:p>
            <a:pPr lvl="3"/>
            <a:r>
              <a:rPr lang="es-ES_tradnl" smtClean="0"/>
              <a:t>Fourth level</a:t>
            </a:r>
          </a:p>
          <a:p>
            <a:pPr lvl="4"/>
            <a:r>
              <a:rPr lang="es-ES_tradnl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8CA3A-1B56-2242-8E8E-10177C94E442}" type="datetimeFigureOut">
              <a:rPr lang="en-US" smtClean="0"/>
              <a:pPr/>
              <a:t>8/20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0EAD3C-6716-144E-8A51-58CFD79B9187}" type="slidenum">
              <a:rPr lang="en-US" smtClean="0"/>
              <a:pPr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7101895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8CA3A-1B56-2242-8E8E-10177C94E442}" type="datetimeFigureOut">
              <a:rPr lang="en-US" smtClean="0"/>
              <a:pPr/>
              <a:t>8/20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0EAD3C-6716-144E-8A51-58CFD79B9187}" type="slidenum">
              <a:rPr lang="en-US" smtClean="0"/>
              <a:pPr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0433400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8CA3A-1B56-2242-8E8E-10177C94E442}" type="datetimeFigureOut">
              <a:rPr lang="en-US" smtClean="0"/>
              <a:pPr/>
              <a:t>8/20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0EAD3C-6716-144E-8A51-58CFD79B9187}" type="slidenum">
              <a:rPr lang="en-US" smtClean="0"/>
              <a:pPr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9718048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_tradnl" smtClean="0"/>
              <a:t>Click to edit Master text styles</a:t>
            </a:r>
          </a:p>
          <a:p>
            <a:pPr lvl="1"/>
            <a:r>
              <a:rPr lang="es-ES_tradnl" smtClean="0"/>
              <a:t>Second level</a:t>
            </a:r>
          </a:p>
          <a:p>
            <a:pPr lvl="2"/>
            <a:r>
              <a:rPr lang="es-ES_tradnl" smtClean="0"/>
              <a:t>Third level</a:t>
            </a:r>
          </a:p>
          <a:p>
            <a:pPr lvl="3"/>
            <a:r>
              <a:rPr lang="es-ES_tradnl" smtClean="0"/>
              <a:t>Fourth level</a:t>
            </a:r>
          </a:p>
          <a:p>
            <a:pPr lvl="4"/>
            <a:r>
              <a:rPr lang="es-ES_tradnl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8CA3A-1B56-2242-8E8E-10177C94E442}" type="datetimeFigureOut">
              <a:rPr lang="en-US" smtClean="0"/>
              <a:pPr/>
              <a:t>8/20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0EAD3C-6716-144E-8A51-58CFD79B9187}" type="slidenum">
              <a:rPr lang="en-US" smtClean="0"/>
              <a:pPr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976788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8CA3A-1B56-2242-8E8E-10177C94E442}" type="datetimeFigureOut">
              <a:rPr lang="en-US" smtClean="0"/>
              <a:pPr/>
              <a:t>8/20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0EAD3C-6716-144E-8A51-58CFD79B9187}" type="slidenum">
              <a:rPr lang="en-US" smtClean="0"/>
              <a:pPr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9767755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_tradnl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_tradnl" smtClean="0"/>
              <a:t>Click to edit Master text styles</a:t>
            </a:r>
          </a:p>
          <a:p>
            <a:pPr lvl="1"/>
            <a:r>
              <a:rPr lang="es-ES_tradnl" smtClean="0"/>
              <a:t>Second level</a:t>
            </a:r>
          </a:p>
          <a:p>
            <a:pPr lvl="2"/>
            <a:r>
              <a:rPr lang="es-ES_tradnl" smtClean="0"/>
              <a:t>Third level</a:t>
            </a:r>
          </a:p>
          <a:p>
            <a:pPr lvl="3"/>
            <a:r>
              <a:rPr lang="es-ES_tradnl" smtClean="0"/>
              <a:t>Fourth level</a:t>
            </a:r>
          </a:p>
          <a:p>
            <a:pPr lvl="4"/>
            <a:r>
              <a:rPr lang="es-ES_tradnl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28CA3A-1B56-2242-8E8E-10177C94E442}" type="datetimeFigureOut">
              <a:rPr lang="en-US" smtClean="0"/>
              <a:pPr/>
              <a:t>8/2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0EAD3C-6716-144E-8A51-58CFD79B9187}" type="slidenum">
              <a:rPr lang="en-US" smtClean="0"/>
              <a:pPr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4712075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="" val="3713179031"/>
              </p:ext>
            </p:extLst>
          </p:nvPr>
        </p:nvGraphicFramePr>
        <p:xfrm>
          <a:off x="134473" y="342897"/>
          <a:ext cx="8844429" cy="5522545"/>
        </p:xfrm>
        <a:graphic>
          <a:graphicData uri="http://schemas.openxmlformats.org/drawingml/2006/table">
            <a:tbl>
              <a:tblPr/>
              <a:tblGrid>
                <a:gridCol w="1688226"/>
                <a:gridCol w="1500646"/>
                <a:gridCol w="1641331"/>
                <a:gridCol w="956661"/>
                <a:gridCol w="947283"/>
                <a:gridCol w="1041073"/>
                <a:gridCol w="1069209"/>
              </a:tblGrid>
              <a:tr h="162697">
                <a:tc gridSpan="7"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upplementary</a:t>
                      </a:r>
                      <a:r>
                        <a:rPr lang="en-US" sz="900" b="1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r>
                        <a:rPr lang="en-US" sz="9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able </a:t>
                      </a:r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. Peptide sequences and predicted recognition by class I and class II HLA alleles frequently found in </a:t>
                      </a:r>
                      <a:r>
                        <a:rPr lang="en-US" sz="9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exicans. 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40760"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0760"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equence</a:t>
                      </a: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redicted Class I allelic recognition</a:t>
                      </a: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redicted Class II allelic recognition</a:t>
                      </a: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46244">
                <a:tc>
                  <a:txBody>
                    <a:bodyPr/>
                    <a:lstStyle/>
                    <a:p>
                      <a:pPr algn="l" fontAlgn="b"/>
                      <a:r>
                        <a:rPr lang="da-DK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eptide ID</a:t>
                      </a: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equence</a:t>
                      </a: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Origin</a:t>
                      </a: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Low affinity</a:t>
                      </a: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igh affinity</a:t>
                      </a: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Low affinity</a:t>
                      </a: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igh affinity</a:t>
                      </a: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6244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andemic H1N1- peptide 1</a:t>
                      </a:r>
                    </a:p>
                  </a:txBody>
                  <a:tcPr marL="7491" marR="7491" marT="7491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KAILVVLLYTFATAN</a:t>
                      </a:r>
                    </a:p>
                  </a:txBody>
                  <a:tcPr marL="7491" marR="7491" marT="7491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onsensus</a:t>
                      </a:r>
                      <a:r>
                        <a:rPr lang="de-DE" sz="7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sequence</a:t>
                      </a:r>
                      <a:endParaRPr lang="de-DE" sz="7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LA-A*0201</a:t>
                      </a: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LA-A*0201</a:t>
                      </a: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LA-DRB1*0301</a:t>
                      </a: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40760">
                <a:tc>
                  <a:txBody>
                    <a:bodyPr/>
                    <a:lstStyle/>
                    <a:p>
                      <a:pPr algn="l" fontAlgn="b"/>
                      <a:endParaRPr lang="en-US" sz="700" b="1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LA-A*1101</a:t>
                      </a: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LA-B*3902</a:t>
                      </a: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LA-DRB1*0701</a:t>
                      </a: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0760"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LA-A*2402</a:t>
                      </a: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LA-B*5101 </a:t>
                      </a: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LA-DRB1*0802</a:t>
                      </a: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0760"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LA-A*6801</a:t>
                      </a: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LA-DRB1*1101</a:t>
                      </a: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0760"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LA-B*3901</a:t>
                      </a: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LA-DRB1*1501</a:t>
                      </a: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0760"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LA-B*4001</a:t>
                      </a: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0760"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LA-B*4402</a:t>
                      </a: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0760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7491" marR="7491" marT="749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7491" marR="7491" marT="749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LA-B*5101 </a:t>
                      </a: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0760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andemic H1N1- peptide 2</a:t>
                      </a:r>
                    </a:p>
                  </a:txBody>
                  <a:tcPr marL="7491" marR="7491" marT="749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RFEIFPKTSSWPNHDSNKG</a:t>
                      </a: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onsensus sequence</a:t>
                      </a:r>
                      <a:endParaRPr lang="de-DE" sz="7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LA-A*0201</a:t>
                      </a: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LA-A*1101</a:t>
                      </a: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LA-DRB1*1101</a:t>
                      </a: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LA-DRB1*0701</a:t>
                      </a: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40760">
                <a:tc>
                  <a:txBody>
                    <a:bodyPr/>
                    <a:lstStyle/>
                    <a:p>
                      <a:pPr algn="l" fontAlgn="b"/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LA-A*1101</a:t>
                      </a: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LA-DRB1*0802</a:t>
                      </a: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0760"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LA-A*6801</a:t>
                      </a: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LA-DRB1*1101</a:t>
                      </a: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0760"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LA-B*4001</a:t>
                      </a: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0760"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LA-B*4402</a:t>
                      </a: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076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LA-B*5101 </a:t>
                      </a: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0760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1N1/ H3N2 common sequence</a:t>
                      </a:r>
                    </a:p>
                  </a:txBody>
                  <a:tcPr marL="7491" marR="7491" marT="749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FGAIAGFIEGGWTGMVDGWY</a:t>
                      </a:r>
                    </a:p>
                  </a:txBody>
                  <a:tcPr marL="7491" marR="7491" marT="749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A/Mexico City/WR1704T/2009(H1N1)</a:t>
                      </a: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LA-A*1101</a:t>
                      </a: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LA-A*0201</a:t>
                      </a: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LA-DRB1*0301</a:t>
                      </a: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40760">
                <a:tc>
                  <a:txBody>
                    <a:bodyPr/>
                    <a:lstStyle/>
                    <a:p>
                      <a:pPr algn="l" fontAlgn="b"/>
                      <a:endParaRPr lang="en-US" sz="700" b="1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LA-A*2402</a:t>
                      </a: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0760"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LA-A*6801</a:t>
                      </a: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0760"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LA-B*4001</a:t>
                      </a: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0760">
                <a:tc>
                  <a:txBody>
                    <a:bodyPr/>
                    <a:lstStyle/>
                    <a:p>
                      <a:pPr algn="l" fontAlgn="b"/>
                      <a:endParaRPr lang="en-US" sz="700" b="1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LA-B*4402</a:t>
                      </a: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0760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LA-B*5101 </a:t>
                      </a: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0760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easonal H1N1-peptide</a:t>
                      </a:r>
                    </a:p>
                  </a:txBody>
                  <a:tcPr marL="7491" marR="7491" marT="749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IINSNAPMDECAKCQTPQ</a:t>
                      </a:r>
                    </a:p>
                  </a:txBody>
                  <a:tcPr marL="7491" marR="7491" marT="749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A/California/06/2008(H1N1)</a:t>
                      </a: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LA-A*0201</a:t>
                      </a: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LA-DRB1*0301</a:t>
                      </a: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40760">
                <a:tc>
                  <a:txBody>
                    <a:bodyPr/>
                    <a:lstStyle/>
                    <a:p>
                      <a:pPr algn="l" fontAlgn="b"/>
                      <a:endParaRPr lang="en-US" sz="700" b="1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LA-A*1101</a:t>
                      </a: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LA-DRB1*0701</a:t>
                      </a: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0760"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LA-A*6801</a:t>
                      </a: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0760"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LA-B*4001</a:t>
                      </a: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0760"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LA-B*4402</a:t>
                      </a: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076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LA-B*5101 </a:t>
                      </a: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0760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easonal H3N2-peptide</a:t>
                      </a:r>
                    </a:p>
                  </a:txBody>
                  <a:tcPr marL="7491" marR="7491" marT="749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QASGRITVSTKRSQQTVI</a:t>
                      </a: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A/Mexico/UASLP-012/2008(H3N2)</a:t>
                      </a: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LA-A*0201</a:t>
                      </a: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LA-A*1101</a:t>
                      </a: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LA-DRB1*0301</a:t>
                      </a: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40760">
                <a:tc>
                  <a:txBody>
                    <a:bodyPr/>
                    <a:lstStyle/>
                    <a:p>
                      <a:pPr algn="l" fontAlgn="b"/>
                      <a:endParaRPr lang="en-US" sz="700" b="1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LA-A*1101</a:t>
                      </a: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LA-DRB1*0701</a:t>
                      </a: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0760"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LA-A*2402</a:t>
                      </a: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LA-DRB1*1501</a:t>
                      </a: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0760"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LA-A*6801</a:t>
                      </a: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0760"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LA-B*3901</a:t>
                      </a: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0760"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LA-B*3902</a:t>
                      </a: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0760"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LA-B*4402</a:t>
                      </a: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076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LA-B*5101 </a:t>
                      </a: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0760"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491" marR="7491" marT="7491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xmlns="" val="340819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133</Words>
  <Application>Microsoft Office PowerPoint</Application>
  <PresentationFormat>Presentación en pantalla (4:3)</PresentationFormat>
  <Paragraphs>111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2" baseType="lpstr">
      <vt:lpstr>Office Theme</vt:lpstr>
      <vt:lpstr>Diapositiva 1</vt:lpstr>
    </vt:vector>
  </TitlesOfParts>
  <Company>HOME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SMERALDA JUAREZ</dc:creator>
  <cp:lastModifiedBy>Usuario</cp:lastModifiedBy>
  <cp:revision>2</cp:revision>
  <dcterms:created xsi:type="dcterms:W3CDTF">2013-08-19T17:03:20Z</dcterms:created>
  <dcterms:modified xsi:type="dcterms:W3CDTF">2013-08-20T19:55:52Z</dcterms:modified>
</cp:coreProperties>
</file>